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D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4" d="100"/>
          <a:sy n="64" d="100"/>
        </p:scale>
        <p:origin x="101" y="379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448DC-FE6A-49F5-8983-C639AAF2B560}" type="datetimeFigureOut">
              <a:rPr lang="en-US" smtClean="0"/>
              <a:t>9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B7C19-AF35-4881-846A-2E8DD685AB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48975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448DC-FE6A-49F5-8983-C639AAF2B560}" type="datetimeFigureOut">
              <a:rPr lang="en-US" smtClean="0"/>
              <a:t>9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B7C19-AF35-4881-846A-2E8DD685AB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6867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448DC-FE6A-49F5-8983-C639AAF2B560}" type="datetimeFigureOut">
              <a:rPr lang="en-US" smtClean="0"/>
              <a:t>9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B7C19-AF35-4881-846A-2E8DD685AB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05489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448DC-FE6A-49F5-8983-C639AAF2B560}" type="datetimeFigureOut">
              <a:rPr lang="en-US" smtClean="0"/>
              <a:t>9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B7C19-AF35-4881-846A-2E8DD685AB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8408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448DC-FE6A-49F5-8983-C639AAF2B560}" type="datetimeFigureOut">
              <a:rPr lang="en-US" smtClean="0"/>
              <a:t>9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B7C19-AF35-4881-846A-2E8DD685AB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1113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448DC-FE6A-49F5-8983-C639AAF2B560}" type="datetimeFigureOut">
              <a:rPr lang="en-US" smtClean="0"/>
              <a:t>9/1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B7C19-AF35-4881-846A-2E8DD685AB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25415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448DC-FE6A-49F5-8983-C639AAF2B560}" type="datetimeFigureOut">
              <a:rPr lang="en-US" smtClean="0"/>
              <a:t>9/13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B7C19-AF35-4881-846A-2E8DD685AB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7408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448DC-FE6A-49F5-8983-C639AAF2B560}" type="datetimeFigureOut">
              <a:rPr lang="en-US" smtClean="0"/>
              <a:t>9/13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B7C19-AF35-4881-846A-2E8DD685AB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79151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448DC-FE6A-49F5-8983-C639AAF2B560}" type="datetimeFigureOut">
              <a:rPr lang="en-US" smtClean="0"/>
              <a:t>9/13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B7C19-AF35-4881-846A-2E8DD685AB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99742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448DC-FE6A-49F5-8983-C639AAF2B560}" type="datetimeFigureOut">
              <a:rPr lang="en-US" smtClean="0"/>
              <a:t>9/1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B7C19-AF35-4881-846A-2E8DD685AB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6853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448DC-FE6A-49F5-8983-C639AAF2B560}" type="datetimeFigureOut">
              <a:rPr lang="en-US" smtClean="0"/>
              <a:t>9/1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B7C19-AF35-4881-846A-2E8DD685AB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82452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0448DC-FE6A-49F5-8983-C639AAF2B560}" type="datetimeFigureOut">
              <a:rPr lang="en-US" smtClean="0"/>
              <a:t>9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FB7C19-AF35-4881-846A-2E8DD685AB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258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Picture 35"/>
          <p:cNvPicPr>
            <a:picLocks noChangeAspect="1"/>
          </p:cNvPicPr>
          <p:nvPr/>
        </p:nvPicPr>
        <p:blipFill rotWithShape="1">
          <a:blip r:embed="rId2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 l="863" t="4295" r="-1"/>
          <a:stretch/>
        </p:blipFill>
        <p:spPr>
          <a:xfrm>
            <a:off x="3232727" y="221672"/>
            <a:ext cx="4990256" cy="6036297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 rot="16200000">
            <a:off x="2287397" y="3150795"/>
            <a:ext cx="7521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ensity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371165" y="6406896"/>
            <a:ext cx="28632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YBR Green Fluorescence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.U.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836470" y="855587"/>
            <a:ext cx="4010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~2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304554" y="644306"/>
            <a:ext cx="4010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~4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5785360" y="26242"/>
            <a:ext cx="4010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~3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8538789" y="2577119"/>
            <a:ext cx="14366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yHDPN1: </a:t>
            </a:r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cer</a:t>
            </a:r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x </a:t>
            </a:r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mik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8545139" y="2816990"/>
            <a:ext cx="20665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yHDPN399: Evolved </a:t>
            </a:r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cer</a:t>
            </a:r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x </a:t>
            </a:r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mik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8538789" y="3037811"/>
            <a:ext cx="14414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yHDPN5: </a:t>
            </a:r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cer</a:t>
            </a:r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x </a:t>
            </a:r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kud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8545139" y="3277682"/>
            <a:ext cx="20714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yHDPN379: Evolved </a:t>
            </a:r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cer</a:t>
            </a:r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x </a:t>
            </a:r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kud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8546110" y="3504853"/>
            <a:ext cx="16514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34/70: </a:t>
            </a:r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cer</a:t>
            </a:r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x </a:t>
            </a:r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ub</a:t>
            </a:r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4n)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8547081" y="3732024"/>
            <a:ext cx="14478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LBRCY73: </a:t>
            </a:r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cer</a:t>
            </a:r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)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812799" y="110180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815735" y="267367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934895" y="580865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300643" y="6225731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.5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4404942" y="6225731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.7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5522453" y="6224175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.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6582217" y="6224175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.2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7710997" y="6224175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.5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tangle 32"/>
          <p:cNvSpPr/>
          <p:nvPr/>
        </p:nvSpPr>
        <p:spPr>
          <a:xfrm>
            <a:off x="7926761" y="1129784"/>
            <a:ext cx="2116511" cy="145513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TextBox 33"/>
          <p:cNvSpPr txBox="1"/>
          <p:nvPr/>
        </p:nvSpPr>
        <p:spPr>
          <a:xfrm>
            <a:off x="8807989" y="2270150"/>
            <a:ext cx="10422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train: Species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Straight Connector 19"/>
          <p:cNvCxnSpPr/>
          <p:nvPr/>
        </p:nvCxnSpPr>
        <p:spPr>
          <a:xfrm>
            <a:off x="8280743" y="2516371"/>
            <a:ext cx="239360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258175" y="2578545"/>
            <a:ext cx="327368" cy="1422005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>
            <a:off x="2822404" y="42407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540757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1</TotalTime>
  <Words>61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VE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Peris</dc:creator>
  <cp:lastModifiedBy>David Peris</cp:lastModifiedBy>
  <cp:revision>27</cp:revision>
  <dcterms:created xsi:type="dcterms:W3CDTF">2015-11-13T00:07:59Z</dcterms:created>
  <dcterms:modified xsi:type="dcterms:W3CDTF">2016-09-13T22:40:08Z</dcterms:modified>
</cp:coreProperties>
</file>